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262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692697" y="539569"/>
          <a:ext cx="5688630" cy="15544800"/>
        </p:xfrm>
        <a:graphic>
          <a:graphicData uri="http://schemas.openxmlformats.org/drawingml/2006/table">
            <a:tbl>
              <a:tblPr/>
              <a:tblGrid>
                <a:gridCol w="526724"/>
                <a:gridCol w="527562"/>
                <a:gridCol w="527562"/>
                <a:gridCol w="527562"/>
                <a:gridCol w="527562"/>
                <a:gridCol w="527562"/>
                <a:gridCol w="984054"/>
                <a:gridCol w="527562"/>
                <a:gridCol w="1012480"/>
              </a:tblGrid>
              <a:tr h="17490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 dirty="0">
                          <a:latin typeface="Garamond"/>
                          <a:ea typeface="Times New Roman"/>
                          <a:cs typeface="Arial"/>
                        </a:rPr>
                        <a:t>Lung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iver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Kidney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eart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lacenta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Gene name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Accession number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Chromosome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osition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lagl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7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L3mbtl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01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Mas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75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4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Igf2r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75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4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lc22a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158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4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lc22a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923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4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ira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177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6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Lilrb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735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6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2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Usp2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177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6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peg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41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6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1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poc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487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2,0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poe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603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8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poe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13882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abrg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2437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0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4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3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abra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729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0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abrb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706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0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1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tp10a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49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0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Ube3a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186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0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23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nrpn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8767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1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5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4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nrpn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11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1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5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nurf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13073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1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8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8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dn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855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6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eg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873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16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mpd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15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6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Inpp5f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937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87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Igf2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15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5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5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4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Igf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009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3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Ins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913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4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9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Th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74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scl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15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5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d8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308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d81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6058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Tssc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1319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4,7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Kcnq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207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dkn1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375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dkn1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375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5,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dkn1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Y35167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lc22a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42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hlda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513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ap1l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NM_001012170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Osbpl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6626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4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Osbpl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913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4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6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hcr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2238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04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Ins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912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5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atm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5752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0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atm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8178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0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ax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066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36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4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07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4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gouti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297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4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nat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36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4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4,5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nat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18168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4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5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6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5,3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nas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57529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6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nas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F10525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6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alcr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40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alcr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L146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Tfpi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17314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8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4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2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pp1r9a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347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on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914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29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8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on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3207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2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on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408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30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on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1308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30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lx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94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31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4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Mest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96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86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6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3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9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lk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37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34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cn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2412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3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Kcnk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34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10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L3mbtl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369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20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4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lc38a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9729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3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Rasgrf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646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94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xin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244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4,3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6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4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pp1c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7882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3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3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Ppp1c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2249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3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d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54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9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dc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U3188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92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36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5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imilar to Grb10 protein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57366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92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8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Rb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443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53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tr2a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725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55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4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6,5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fmbt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555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9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6,5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md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6976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X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1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7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5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8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md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52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X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71 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0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md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524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X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71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1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4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md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1269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X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71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56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6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md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Y326949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rX</a:t>
                      </a:r>
                      <a:endParaRPr lang="fr-FR" sz="7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71 </a:t>
                      </a:r>
                      <a:endParaRPr lang="fr-FR" sz="7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7824" marR="78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20481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Garamond" pitchFamily="18" charset="0"/>
                <a:ea typeface="Calibri" pitchFamily="34" charset="0"/>
                <a:cs typeface="Times New Roman" pitchFamily="18" charset="0"/>
              </a:rPr>
              <a:t>Supplementary Table II: list of imprinted genes and their degree of transcriptional modification by induced IUGR in the rat model.</a:t>
            </a:r>
            <a:endParaRPr kumimoji="0" lang="fr-FR" sz="5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00</Words>
  <Application>Microsoft Office PowerPoint</Application>
  <PresentationFormat>Affichage à l'écran (4:3)</PresentationFormat>
  <Paragraphs>75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niel</dc:creator>
  <cp:lastModifiedBy>Daniel</cp:lastModifiedBy>
  <cp:revision>6</cp:revision>
  <dcterms:created xsi:type="dcterms:W3CDTF">2011-05-25T16:59:47Z</dcterms:created>
  <dcterms:modified xsi:type="dcterms:W3CDTF">2011-05-25T17:01:41Z</dcterms:modified>
</cp:coreProperties>
</file>